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16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4/11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F:\文档\新医实验\J proteome Research\杨改1\补充材料\B4YAH7-TEQGPQVDETQFK.bmp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9765" y="1142984"/>
            <a:ext cx="9114235" cy="2857520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2857488" y="4572008"/>
            <a:ext cx="36433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ALDH2</a:t>
            </a:r>
            <a:r>
              <a:rPr lang="en-US" altLang="zh-CN" dirty="0" smtClean="0"/>
              <a:t> </a:t>
            </a:r>
          </a:p>
          <a:p>
            <a:pPr algn="ctr"/>
            <a:r>
              <a:rPr lang="en-US" altLang="zh-CN" dirty="0" smtClean="0"/>
              <a:t>B4YAH7-TEQGPQVDETQFK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F:\文档\新医实验\J proteome Research\杨改1\补充材料\O60701-EQIVVDLSHPGVSEDDQVSR.bmp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1071546"/>
            <a:ext cx="9159091" cy="2871583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2857488" y="4572008"/>
            <a:ext cx="36433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UGDH</a:t>
            </a:r>
            <a:r>
              <a:rPr lang="en-US" altLang="zh-CN" dirty="0" smtClean="0"/>
              <a:t> </a:t>
            </a:r>
          </a:p>
          <a:p>
            <a:pPr algn="ctr"/>
            <a:r>
              <a:rPr lang="en-US" altLang="zh-CN" dirty="0" smtClean="0"/>
              <a:t>O60701-EQIVVDLSHPGVSEDDQVSR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57488" y="4572008"/>
            <a:ext cx="36433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DKK1 </a:t>
            </a:r>
          </a:p>
          <a:p>
            <a:pPr algn="ctr"/>
            <a:r>
              <a:rPr lang="en-US" altLang="zh-CN" dirty="0" smtClean="0"/>
              <a:t>O94907-SSDCASGLCCAR</a:t>
            </a:r>
            <a:endParaRPr lang="zh-CN" altLang="en-US" dirty="0"/>
          </a:p>
        </p:txBody>
      </p:sp>
      <p:pic>
        <p:nvPicPr>
          <p:cNvPr id="3074" name="Picture 2" descr="F:\文档\新医实验\J proteome Research\杨改1\补充材料\O94907-SSDCASGLCCAR.bmp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1142984"/>
            <a:ext cx="9144000" cy="2866853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57488" y="4572008"/>
            <a:ext cx="36433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ANXA4</a:t>
            </a:r>
          </a:p>
          <a:p>
            <a:pPr algn="ctr"/>
            <a:r>
              <a:rPr lang="en-US" altLang="zh-CN" dirty="0" smtClean="0"/>
              <a:t>P09525-GLGTDEDAIISVLAYR</a:t>
            </a:r>
            <a:endParaRPr lang="zh-CN" altLang="en-US" dirty="0"/>
          </a:p>
        </p:txBody>
      </p:sp>
      <p:pic>
        <p:nvPicPr>
          <p:cNvPr id="4098" name="Picture 2" descr="F:\文档\新医实验\J proteome Research\杨改1\补充材料\P09525-GLGTDEDAIISVLAYR.bmp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1000108"/>
            <a:ext cx="9203413" cy="288548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57488" y="4572008"/>
            <a:ext cx="36433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FABP4</a:t>
            </a:r>
          </a:p>
          <a:p>
            <a:pPr algn="ctr"/>
            <a:r>
              <a:rPr lang="en-US" altLang="zh-CN" dirty="0" smtClean="0"/>
              <a:t>P15090-LVSSENFDDYMK</a:t>
            </a:r>
            <a:endParaRPr lang="zh-CN" altLang="en-US" dirty="0"/>
          </a:p>
        </p:txBody>
      </p:sp>
      <p:pic>
        <p:nvPicPr>
          <p:cNvPr id="5122" name="Picture 2" descr="F:\文档\新医实验\J proteome Research\杨改1\补充材料\P15090-LVSSENFDDYMK.bmp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1000108"/>
            <a:ext cx="9186143" cy="2880065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57488" y="4572008"/>
            <a:ext cx="36433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/>
              <a:t>PPIA</a:t>
            </a:r>
          </a:p>
          <a:p>
            <a:pPr algn="ctr"/>
            <a:r>
              <a:rPr lang="en-US" altLang="zh-CN" dirty="0" smtClean="0"/>
              <a:t>Q71V99-VNPTVFFDITADDEPLGR</a:t>
            </a:r>
            <a:endParaRPr lang="zh-CN" altLang="en-US" dirty="0"/>
          </a:p>
        </p:txBody>
      </p:sp>
      <p:pic>
        <p:nvPicPr>
          <p:cNvPr id="6146" name="Picture 2" descr="F:\文档\新医实验\J proteome Research\杨改1\补充材料\Q71V99-VNPTVFFDITADDEPLGR.bmp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" y="812913"/>
            <a:ext cx="9144000" cy="2866852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</Words>
  <PresentationFormat>全屏显示(4:3)</PresentationFormat>
  <Paragraphs>12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yingqi</dc:creator>
  <cp:lastModifiedBy>yingqi</cp:lastModifiedBy>
  <cp:revision>1</cp:revision>
  <dcterms:created xsi:type="dcterms:W3CDTF">2014-11-19T02:46:47Z</dcterms:created>
  <dcterms:modified xsi:type="dcterms:W3CDTF">2014-11-19T02:55:03Z</dcterms:modified>
</cp:coreProperties>
</file>